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F759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948" autoAdjust="0"/>
  </p:normalViewPr>
  <p:slideViewPr>
    <p:cSldViewPr>
      <p:cViewPr varScale="1">
        <p:scale>
          <a:sx n="98" d="100"/>
          <a:sy n="98" d="100"/>
        </p:scale>
        <p:origin x="-206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BMC%20Genomics\RT-PCR%20gene\RT-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2!$B$56:$K$56</c:f>
                <c:numCache>
                  <c:formatCode>General</c:formatCode>
                  <c:ptCount val="10"/>
                  <c:pt idx="0">
                    <c:v>0.13</c:v>
                  </c:pt>
                  <c:pt idx="1">
                    <c:v>0.12</c:v>
                  </c:pt>
                  <c:pt idx="2">
                    <c:v>0.01</c:v>
                  </c:pt>
                  <c:pt idx="3">
                    <c:v>0.04</c:v>
                  </c:pt>
                  <c:pt idx="4">
                    <c:v>0.09</c:v>
                  </c:pt>
                  <c:pt idx="5">
                    <c:v>0.13</c:v>
                  </c:pt>
                  <c:pt idx="6">
                    <c:v>0.41</c:v>
                  </c:pt>
                  <c:pt idx="7">
                    <c:v>0.32</c:v>
                  </c:pt>
                  <c:pt idx="8">
                    <c:v>0.26</c:v>
                  </c:pt>
                  <c:pt idx="9">
                    <c:v>0.55000000000000004</c:v>
                  </c:pt>
                </c:numCache>
              </c:numRef>
            </c:plus>
            <c:minus>
              <c:numRef>
                <c:f>Sheet2!$B$56:$K$56</c:f>
                <c:numCache>
                  <c:formatCode>General</c:formatCode>
                  <c:ptCount val="10"/>
                  <c:pt idx="0">
                    <c:v>0.13</c:v>
                  </c:pt>
                  <c:pt idx="1">
                    <c:v>0.12</c:v>
                  </c:pt>
                  <c:pt idx="2">
                    <c:v>0.01</c:v>
                  </c:pt>
                  <c:pt idx="3">
                    <c:v>0.04</c:v>
                  </c:pt>
                  <c:pt idx="4">
                    <c:v>0.09</c:v>
                  </c:pt>
                  <c:pt idx="5">
                    <c:v>0.13</c:v>
                  </c:pt>
                  <c:pt idx="6">
                    <c:v>0.41</c:v>
                  </c:pt>
                  <c:pt idx="7">
                    <c:v>0.32</c:v>
                  </c:pt>
                  <c:pt idx="8">
                    <c:v>0.26</c:v>
                  </c:pt>
                  <c:pt idx="9">
                    <c:v>0.55000000000000004</c:v>
                  </c:pt>
                </c:numCache>
              </c:numRef>
            </c:minus>
          </c:errBars>
          <c:val>
            <c:numRef>
              <c:f>Sheet2!$B$49:$K$49</c:f>
              <c:numCache>
                <c:formatCode>0.00_ </c:formatCode>
                <c:ptCount val="10"/>
                <c:pt idx="0">
                  <c:v>-0.79458263994866996</c:v>
                </c:pt>
                <c:pt idx="1">
                  <c:v>-0.64602964485087355</c:v>
                </c:pt>
                <c:pt idx="2">
                  <c:v>3.7197418494272001E-2</c:v>
                </c:pt>
                <c:pt idx="3">
                  <c:v>-0.14124466529824001</c:v>
                </c:pt>
                <c:pt idx="4">
                  <c:v>0.322215228310678</c:v>
                </c:pt>
                <c:pt idx="5">
                  <c:v>0.92171041785559304</c:v>
                </c:pt>
                <c:pt idx="6">
                  <c:v>1.9447584796771833</c:v>
                </c:pt>
                <c:pt idx="7">
                  <c:v>1.7747757731432732</c:v>
                </c:pt>
                <c:pt idx="8">
                  <c:v>3.2193703651755801</c:v>
                </c:pt>
                <c:pt idx="9">
                  <c:v>4.6222920095655002</c:v>
                </c:pt>
              </c:numCache>
            </c:numRef>
          </c:val>
        </c:ser>
        <c:ser>
          <c:idx val="1"/>
          <c:order val="1"/>
          <c:invertIfNegative val="0"/>
          <c:errBars>
            <c:errBarType val="both"/>
            <c:errValType val="cust"/>
            <c:noEndCap val="0"/>
            <c:plus>
              <c:numRef>
                <c:f>Sheet2!$B$57:$K$57</c:f>
                <c:numCache>
                  <c:formatCode>General</c:formatCode>
                  <c:ptCount val="10"/>
                  <c:pt idx="0">
                    <c:v>0.04</c:v>
                  </c:pt>
                  <c:pt idx="1">
                    <c:v>0.06</c:v>
                  </c:pt>
                  <c:pt idx="2">
                    <c:v>0.11</c:v>
                  </c:pt>
                  <c:pt idx="3">
                    <c:v>0.39</c:v>
                  </c:pt>
                  <c:pt idx="4">
                    <c:v>0.1</c:v>
                  </c:pt>
                  <c:pt idx="5">
                    <c:v>0.22</c:v>
                  </c:pt>
                  <c:pt idx="6">
                    <c:v>0.22</c:v>
                  </c:pt>
                  <c:pt idx="7">
                    <c:v>0.49</c:v>
                  </c:pt>
                  <c:pt idx="8">
                    <c:v>0.42</c:v>
                  </c:pt>
                  <c:pt idx="9">
                    <c:v>0.32</c:v>
                  </c:pt>
                </c:numCache>
              </c:numRef>
            </c:plus>
            <c:minus>
              <c:numRef>
                <c:f>Sheet2!$B$57:$K$57</c:f>
                <c:numCache>
                  <c:formatCode>General</c:formatCode>
                  <c:ptCount val="10"/>
                  <c:pt idx="0">
                    <c:v>0.04</c:v>
                  </c:pt>
                  <c:pt idx="1">
                    <c:v>0.06</c:v>
                  </c:pt>
                  <c:pt idx="2">
                    <c:v>0.11</c:v>
                  </c:pt>
                  <c:pt idx="3">
                    <c:v>0.39</c:v>
                  </c:pt>
                  <c:pt idx="4">
                    <c:v>0.1</c:v>
                  </c:pt>
                  <c:pt idx="5">
                    <c:v>0.22</c:v>
                  </c:pt>
                  <c:pt idx="6">
                    <c:v>0.22</c:v>
                  </c:pt>
                  <c:pt idx="7">
                    <c:v>0.49</c:v>
                  </c:pt>
                  <c:pt idx="8">
                    <c:v>0.42</c:v>
                  </c:pt>
                  <c:pt idx="9">
                    <c:v>0.32</c:v>
                  </c:pt>
                </c:numCache>
              </c:numRef>
            </c:minus>
          </c:errBars>
          <c:val>
            <c:numRef>
              <c:f>Sheet2!$B$50:$K$50</c:f>
              <c:numCache>
                <c:formatCode>0.00_ </c:formatCode>
                <c:ptCount val="10"/>
                <c:pt idx="0">
                  <c:v>-0.1712678197555472</c:v>
                </c:pt>
                <c:pt idx="1">
                  <c:v>-0.2948632696665211</c:v>
                </c:pt>
                <c:pt idx="2">
                  <c:v>0.76259810646059001</c:v>
                </c:pt>
                <c:pt idx="3">
                  <c:v>1.9723437024210539</c:v>
                </c:pt>
                <c:pt idx="4">
                  <c:v>1.545261517293617</c:v>
                </c:pt>
                <c:pt idx="5">
                  <c:v>1.92478291128288</c:v>
                </c:pt>
                <c:pt idx="6">
                  <c:v>2.395477606045413</c:v>
                </c:pt>
                <c:pt idx="7">
                  <c:v>3.91800242454722</c:v>
                </c:pt>
                <c:pt idx="8">
                  <c:v>4.4016376393853998</c:v>
                </c:pt>
                <c:pt idx="9">
                  <c:v>2.0370760362047551</c:v>
                </c:pt>
              </c:numCache>
            </c:numRef>
          </c:val>
        </c:ser>
        <c:ser>
          <c:idx val="2"/>
          <c:order val="2"/>
          <c:invertIfNegative val="0"/>
          <c:errBars>
            <c:errBarType val="both"/>
            <c:errValType val="cust"/>
            <c:noEndCap val="0"/>
            <c:plus>
              <c:numRef>
                <c:f>Sheet2!$B$58:$K$58</c:f>
                <c:numCache>
                  <c:formatCode>General</c:formatCode>
                  <c:ptCount val="10"/>
                  <c:pt idx="0">
                    <c:v>0.04</c:v>
                  </c:pt>
                  <c:pt idx="1">
                    <c:v>0.21</c:v>
                  </c:pt>
                  <c:pt idx="2">
                    <c:v>0.02</c:v>
                  </c:pt>
                  <c:pt idx="3">
                    <c:v>0.06</c:v>
                  </c:pt>
                  <c:pt idx="4">
                    <c:v>0.09</c:v>
                  </c:pt>
                  <c:pt idx="5">
                    <c:v>0.09</c:v>
                  </c:pt>
                  <c:pt idx="6">
                    <c:v>0.3</c:v>
                  </c:pt>
                  <c:pt idx="7">
                    <c:v>0.35</c:v>
                  </c:pt>
                  <c:pt idx="8">
                    <c:v>0.23</c:v>
                  </c:pt>
                  <c:pt idx="9">
                    <c:v>0.23</c:v>
                  </c:pt>
                </c:numCache>
              </c:numRef>
            </c:plus>
            <c:minus>
              <c:numRef>
                <c:f>Sheet2!$B$58:$K$58</c:f>
                <c:numCache>
                  <c:formatCode>General</c:formatCode>
                  <c:ptCount val="10"/>
                  <c:pt idx="0">
                    <c:v>0.04</c:v>
                  </c:pt>
                  <c:pt idx="1">
                    <c:v>0.21</c:v>
                  </c:pt>
                  <c:pt idx="2">
                    <c:v>0.02</c:v>
                  </c:pt>
                  <c:pt idx="3">
                    <c:v>0.06</c:v>
                  </c:pt>
                  <c:pt idx="4">
                    <c:v>0.09</c:v>
                  </c:pt>
                  <c:pt idx="5">
                    <c:v>0.09</c:v>
                  </c:pt>
                  <c:pt idx="6">
                    <c:v>0.3</c:v>
                  </c:pt>
                  <c:pt idx="7">
                    <c:v>0.35</c:v>
                  </c:pt>
                  <c:pt idx="8">
                    <c:v>0.23</c:v>
                  </c:pt>
                  <c:pt idx="9">
                    <c:v>0.23</c:v>
                  </c:pt>
                </c:numCache>
              </c:numRef>
            </c:minus>
          </c:errBars>
          <c:val>
            <c:numRef>
              <c:f>Sheet2!$B$51:$K$51</c:f>
              <c:numCache>
                <c:formatCode>0.00_ </c:formatCode>
                <c:ptCount val="10"/>
                <c:pt idx="0">
                  <c:v>0.21025787859887632</c:v>
                </c:pt>
                <c:pt idx="1">
                  <c:v>-0.89423573427176262</c:v>
                </c:pt>
                <c:pt idx="2">
                  <c:v>0.15366970471844418</c:v>
                </c:pt>
                <c:pt idx="3">
                  <c:v>0.30782408630563862</c:v>
                </c:pt>
                <c:pt idx="4">
                  <c:v>0.90544443086064252</c:v>
                </c:pt>
                <c:pt idx="5">
                  <c:v>0.3126544768444251</c:v>
                </c:pt>
                <c:pt idx="6">
                  <c:v>1.1548468697953367</c:v>
                </c:pt>
                <c:pt idx="7">
                  <c:v>3.1736441897568</c:v>
                </c:pt>
                <c:pt idx="8">
                  <c:v>3.3951385129059184</c:v>
                </c:pt>
                <c:pt idx="9">
                  <c:v>1.0209938561275138</c:v>
                </c:pt>
              </c:numCache>
            </c:numRef>
          </c:val>
        </c:ser>
        <c:ser>
          <c:idx val="3"/>
          <c:order val="3"/>
          <c:invertIfNegative val="0"/>
          <c:errBars>
            <c:errBarType val="both"/>
            <c:errValType val="cust"/>
            <c:noEndCap val="0"/>
            <c:plus>
              <c:numRef>
                <c:f>Sheet2!$B$59:$K$59</c:f>
                <c:numCache>
                  <c:formatCode>General</c:formatCode>
                  <c:ptCount val="10"/>
                  <c:pt idx="0">
                    <c:v>0.04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4</c:v>
                  </c:pt>
                  <c:pt idx="4">
                    <c:v>0.19</c:v>
                  </c:pt>
                  <c:pt idx="5">
                    <c:v>0.15</c:v>
                  </c:pt>
                  <c:pt idx="6">
                    <c:v>0.28999999999999998</c:v>
                  </c:pt>
                  <c:pt idx="7">
                    <c:v>0.43</c:v>
                  </c:pt>
                  <c:pt idx="8">
                    <c:v>0.39</c:v>
                  </c:pt>
                  <c:pt idx="9">
                    <c:v>0.43</c:v>
                  </c:pt>
                </c:numCache>
              </c:numRef>
            </c:plus>
            <c:minus>
              <c:numRef>
                <c:f>Sheet2!$B$59:$K$59</c:f>
                <c:numCache>
                  <c:formatCode>General</c:formatCode>
                  <c:ptCount val="10"/>
                  <c:pt idx="0">
                    <c:v>0.04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4</c:v>
                  </c:pt>
                  <c:pt idx="4">
                    <c:v>0.19</c:v>
                  </c:pt>
                  <c:pt idx="5">
                    <c:v>0.15</c:v>
                  </c:pt>
                  <c:pt idx="6">
                    <c:v>0.28999999999999998</c:v>
                  </c:pt>
                  <c:pt idx="7">
                    <c:v>0.43</c:v>
                  </c:pt>
                  <c:pt idx="8">
                    <c:v>0.39</c:v>
                  </c:pt>
                  <c:pt idx="9">
                    <c:v>0.43</c:v>
                  </c:pt>
                </c:numCache>
              </c:numRef>
            </c:minus>
          </c:errBars>
          <c:val>
            <c:numRef>
              <c:f>Sheet2!$B$52:$K$52</c:f>
              <c:numCache>
                <c:formatCode>0.00_ </c:formatCode>
                <c:ptCount val="10"/>
                <c:pt idx="0">
                  <c:v>-0.23970259880832001</c:v>
                </c:pt>
                <c:pt idx="1">
                  <c:v>-0.216356397113804</c:v>
                </c:pt>
                <c:pt idx="2">
                  <c:v>0.11496345217232914</c:v>
                </c:pt>
                <c:pt idx="3">
                  <c:v>0.20118908454819345</c:v>
                </c:pt>
                <c:pt idx="4">
                  <c:v>0.75269501020658647</c:v>
                </c:pt>
                <c:pt idx="5">
                  <c:v>1.090065716518742</c:v>
                </c:pt>
                <c:pt idx="6">
                  <c:v>2.1285994510836312</c:v>
                </c:pt>
                <c:pt idx="7">
                  <c:v>3.4497397844931998</c:v>
                </c:pt>
                <c:pt idx="8">
                  <c:v>1.1638858893499906</c:v>
                </c:pt>
                <c:pt idx="9">
                  <c:v>2.08842235272173</c:v>
                </c:pt>
              </c:numCache>
            </c:numRef>
          </c:val>
        </c:ser>
        <c:ser>
          <c:idx val="4"/>
          <c:order val="4"/>
          <c:invertIfNegative val="0"/>
          <c:errBars>
            <c:errBarType val="both"/>
            <c:errValType val="cust"/>
            <c:noEndCap val="0"/>
            <c:plus>
              <c:numRef>
                <c:f>Sheet2!$B$60:$K$60</c:f>
                <c:numCache>
                  <c:formatCode>General</c:formatCode>
                  <c:ptCount val="10"/>
                  <c:pt idx="0">
                    <c:v>0.02</c:v>
                  </c:pt>
                  <c:pt idx="1">
                    <c:v>0.14000000000000001</c:v>
                  </c:pt>
                  <c:pt idx="2">
                    <c:v>0.12</c:v>
                  </c:pt>
                  <c:pt idx="3">
                    <c:v>0.33</c:v>
                  </c:pt>
                  <c:pt idx="4">
                    <c:v>0.06</c:v>
                  </c:pt>
                  <c:pt idx="5">
                    <c:v>7.0000000000000007E-2</c:v>
                  </c:pt>
                  <c:pt idx="6">
                    <c:v>0.19</c:v>
                  </c:pt>
                  <c:pt idx="7">
                    <c:v>0.52</c:v>
                  </c:pt>
                  <c:pt idx="8">
                    <c:v>0.33</c:v>
                  </c:pt>
                  <c:pt idx="9">
                    <c:v>0.31</c:v>
                  </c:pt>
                </c:numCache>
              </c:numRef>
            </c:plus>
            <c:minus>
              <c:numRef>
                <c:f>Sheet2!$B$60:$K$60</c:f>
                <c:numCache>
                  <c:formatCode>General</c:formatCode>
                  <c:ptCount val="10"/>
                  <c:pt idx="0">
                    <c:v>0.02</c:v>
                  </c:pt>
                  <c:pt idx="1">
                    <c:v>0.14000000000000001</c:v>
                  </c:pt>
                  <c:pt idx="2">
                    <c:v>0.12</c:v>
                  </c:pt>
                  <c:pt idx="3">
                    <c:v>0.33</c:v>
                  </c:pt>
                  <c:pt idx="4">
                    <c:v>0.06</c:v>
                  </c:pt>
                  <c:pt idx="5">
                    <c:v>7.0000000000000007E-2</c:v>
                  </c:pt>
                  <c:pt idx="6">
                    <c:v>0.19</c:v>
                  </c:pt>
                  <c:pt idx="7">
                    <c:v>0.52</c:v>
                  </c:pt>
                  <c:pt idx="8">
                    <c:v>0.33</c:v>
                  </c:pt>
                  <c:pt idx="9">
                    <c:v>0.31</c:v>
                  </c:pt>
                </c:numCache>
              </c:numRef>
            </c:minus>
          </c:errBars>
          <c:val>
            <c:numRef>
              <c:f>Sheet2!$B$53:$K$53</c:f>
              <c:numCache>
                <c:formatCode>0.00_ </c:formatCode>
                <c:ptCount val="10"/>
                <c:pt idx="0">
                  <c:v>5.0314388148388234E-2</c:v>
                </c:pt>
                <c:pt idx="1">
                  <c:v>-0.53634831223386903</c:v>
                </c:pt>
                <c:pt idx="2">
                  <c:v>0.27418368411396055</c:v>
                </c:pt>
                <c:pt idx="3">
                  <c:v>1.2361889979401819</c:v>
                </c:pt>
                <c:pt idx="4">
                  <c:v>0.49549949686041822</c:v>
                </c:pt>
                <c:pt idx="5">
                  <c:v>0.16836314746322403</c:v>
                </c:pt>
                <c:pt idx="6">
                  <c:v>0.68831054384852808</c:v>
                </c:pt>
                <c:pt idx="7">
                  <c:v>3.6112601537713149</c:v>
                </c:pt>
                <c:pt idx="8">
                  <c:v>3.0163121158701598</c:v>
                </c:pt>
                <c:pt idx="9">
                  <c:v>2.3241034973702601</c:v>
                </c:pt>
              </c:numCache>
            </c:numRef>
          </c:val>
        </c:ser>
        <c:ser>
          <c:idx val="5"/>
          <c:order val="5"/>
          <c:invertIfNegative val="0"/>
          <c:errBars>
            <c:errBarType val="both"/>
            <c:errValType val="cust"/>
            <c:noEndCap val="0"/>
            <c:plus>
              <c:numRef>
                <c:f>Sheet2!$B$61:$K$61</c:f>
                <c:numCache>
                  <c:formatCode>General</c:formatCode>
                  <c:ptCount val="10"/>
                  <c:pt idx="0">
                    <c:v>7.0000000000000007E-2</c:v>
                  </c:pt>
                  <c:pt idx="1">
                    <c:v>0.03</c:v>
                  </c:pt>
                  <c:pt idx="2">
                    <c:v>0.1</c:v>
                  </c:pt>
                  <c:pt idx="3">
                    <c:v>0.05</c:v>
                  </c:pt>
                  <c:pt idx="4">
                    <c:v>0.09</c:v>
                  </c:pt>
                  <c:pt idx="5">
                    <c:v>0.18</c:v>
                  </c:pt>
                  <c:pt idx="6">
                    <c:v>0.03</c:v>
                  </c:pt>
                  <c:pt idx="7">
                    <c:v>0.36</c:v>
                  </c:pt>
                  <c:pt idx="8">
                    <c:v>0.23</c:v>
                  </c:pt>
                  <c:pt idx="9">
                    <c:v>0.26</c:v>
                  </c:pt>
                </c:numCache>
              </c:numRef>
            </c:plus>
            <c:minus>
              <c:numRef>
                <c:f>Sheet2!$B$61:$K$61</c:f>
                <c:numCache>
                  <c:formatCode>General</c:formatCode>
                  <c:ptCount val="10"/>
                  <c:pt idx="0">
                    <c:v>7.0000000000000007E-2</c:v>
                  </c:pt>
                  <c:pt idx="1">
                    <c:v>0.03</c:v>
                  </c:pt>
                  <c:pt idx="2">
                    <c:v>0.1</c:v>
                  </c:pt>
                  <c:pt idx="3">
                    <c:v>0.05</c:v>
                  </c:pt>
                  <c:pt idx="4">
                    <c:v>0.09</c:v>
                  </c:pt>
                  <c:pt idx="5">
                    <c:v>0.18</c:v>
                  </c:pt>
                  <c:pt idx="6">
                    <c:v>0.03</c:v>
                  </c:pt>
                  <c:pt idx="7">
                    <c:v>0.36</c:v>
                  </c:pt>
                  <c:pt idx="8">
                    <c:v>0.23</c:v>
                  </c:pt>
                  <c:pt idx="9">
                    <c:v>0.26</c:v>
                  </c:pt>
                </c:numCache>
              </c:numRef>
            </c:minus>
          </c:errBars>
          <c:val>
            <c:numRef>
              <c:f>Sheet2!$B$54:$K$54</c:f>
              <c:numCache>
                <c:formatCode>0.00_ </c:formatCode>
                <c:ptCount val="10"/>
                <c:pt idx="0">
                  <c:v>0.47444901138407614</c:v>
                </c:pt>
                <c:pt idx="1">
                  <c:v>0.1254129266363094</c:v>
                </c:pt>
                <c:pt idx="2">
                  <c:v>0.26812554108243963</c:v>
                </c:pt>
                <c:pt idx="3">
                  <c:v>0.18859542842813873</c:v>
                </c:pt>
                <c:pt idx="4">
                  <c:v>0.25936392128360641</c:v>
                </c:pt>
                <c:pt idx="5">
                  <c:v>1.1230390018315806</c:v>
                </c:pt>
                <c:pt idx="6">
                  <c:v>-8.5382779431429995E-2</c:v>
                </c:pt>
                <c:pt idx="7">
                  <c:v>4.0584626827116796</c:v>
                </c:pt>
                <c:pt idx="8">
                  <c:v>2.21941461564731</c:v>
                </c:pt>
                <c:pt idx="9">
                  <c:v>0.99375303052371888</c:v>
                </c:pt>
              </c:numCache>
            </c:numRef>
          </c:val>
        </c:ser>
        <c:ser>
          <c:idx val="6"/>
          <c:order val="6"/>
          <c:invertIfNegative val="0"/>
          <c:errBars>
            <c:errBarType val="both"/>
            <c:errValType val="cust"/>
            <c:noEndCap val="0"/>
            <c:plus>
              <c:numRef>
                <c:f>Sheet2!$B$62:$K$62</c:f>
                <c:numCache>
                  <c:formatCode>General</c:formatCode>
                  <c:ptCount val="10"/>
                  <c:pt idx="0">
                    <c:v>0.02</c:v>
                  </c:pt>
                  <c:pt idx="1">
                    <c:v>0.06</c:v>
                  </c:pt>
                  <c:pt idx="2">
                    <c:v>0.03</c:v>
                  </c:pt>
                  <c:pt idx="3">
                    <c:v>0.05</c:v>
                  </c:pt>
                  <c:pt idx="4">
                    <c:v>0.02</c:v>
                  </c:pt>
                  <c:pt idx="5">
                    <c:v>0.03</c:v>
                  </c:pt>
                  <c:pt idx="6">
                    <c:v>0.2</c:v>
                  </c:pt>
                  <c:pt idx="7">
                    <c:v>0.28999999999999998</c:v>
                  </c:pt>
                  <c:pt idx="8">
                    <c:v>0.26</c:v>
                  </c:pt>
                  <c:pt idx="9">
                    <c:v>0.3</c:v>
                  </c:pt>
                </c:numCache>
              </c:numRef>
            </c:plus>
            <c:minus>
              <c:numRef>
                <c:f>Sheet2!$B$62:$K$62</c:f>
                <c:numCache>
                  <c:formatCode>General</c:formatCode>
                  <c:ptCount val="10"/>
                  <c:pt idx="0">
                    <c:v>0.02</c:v>
                  </c:pt>
                  <c:pt idx="1">
                    <c:v>0.06</c:v>
                  </c:pt>
                  <c:pt idx="2">
                    <c:v>0.03</c:v>
                  </c:pt>
                  <c:pt idx="3">
                    <c:v>0.05</c:v>
                  </c:pt>
                  <c:pt idx="4">
                    <c:v>0.02</c:v>
                  </c:pt>
                  <c:pt idx="5">
                    <c:v>0.03</c:v>
                  </c:pt>
                  <c:pt idx="6">
                    <c:v>0.2</c:v>
                  </c:pt>
                  <c:pt idx="7">
                    <c:v>0.28999999999999998</c:v>
                  </c:pt>
                  <c:pt idx="8">
                    <c:v>0.26</c:v>
                  </c:pt>
                  <c:pt idx="9">
                    <c:v>0.3</c:v>
                  </c:pt>
                </c:numCache>
              </c:numRef>
            </c:minus>
          </c:errBars>
          <c:val>
            <c:numRef>
              <c:f>Sheet2!$B$55:$K$55</c:f>
              <c:numCache>
                <c:formatCode>0.00_ </c:formatCode>
                <c:ptCount val="10"/>
                <c:pt idx="0">
                  <c:v>3.6261434756933747E-2</c:v>
                </c:pt>
                <c:pt idx="1">
                  <c:v>-0.63958723820225005</c:v>
                </c:pt>
                <c:pt idx="2">
                  <c:v>0.13074055597133</c:v>
                </c:pt>
                <c:pt idx="3">
                  <c:v>0.28887456779380083</c:v>
                </c:pt>
                <c:pt idx="4">
                  <c:v>-0.14605877024793301</c:v>
                </c:pt>
                <c:pt idx="5">
                  <c:v>9.4064805450530004E-2</c:v>
                </c:pt>
                <c:pt idx="6">
                  <c:v>0.76088032990694132</c:v>
                </c:pt>
                <c:pt idx="7">
                  <c:v>4.6739026637040002</c:v>
                </c:pt>
                <c:pt idx="8">
                  <c:v>2.5163718352953501</c:v>
                </c:pt>
                <c:pt idx="9">
                  <c:v>3.12026764993454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953984"/>
        <c:axId val="198963968"/>
      </c:barChart>
      <c:catAx>
        <c:axId val="198953984"/>
        <c:scaling>
          <c:orientation val="minMax"/>
        </c:scaling>
        <c:delete val="0"/>
        <c:axPos val="b"/>
        <c:numFmt formatCode="@" sourceLinked="0"/>
        <c:majorTickMark val="out"/>
        <c:minorTickMark val="none"/>
        <c:tickLblPos val="nextTo"/>
        <c:spPr>
          <a:noFill/>
        </c:spPr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zh-CN"/>
          </a:p>
        </c:txPr>
        <c:crossAx val="198963968"/>
        <c:crosses val="autoZero"/>
        <c:auto val="1"/>
        <c:lblAlgn val="ctr"/>
        <c:lblOffset val="100"/>
        <c:noMultiLvlLbl val="0"/>
      </c:catAx>
      <c:valAx>
        <c:axId val="1989639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0_ 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zh-CN"/>
          </a:p>
        </c:txPr>
        <c:crossAx val="19895398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8B0BF-9305-444A-9B42-9AF5452CAB4A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D22069-E321-40C2-8989-F2E29AF2DC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4372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22069-E321-40C2-8989-F2E29AF2DCE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75882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588192" y="4772248"/>
            <a:ext cx="83529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ditional file 3: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Relative expression pattern of 10 selective genes in husk versus other tissues verified using RT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expression in each tissue was first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ormalized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UBQ1 (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MZM2G409726). Y-axi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relative expression of each gene in husk relativ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ther tissues as indicated (log2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cale). Data is shown as the mean ± SD of three independent experiments.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-784599" y="2213431"/>
            <a:ext cx="2101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expression </a:t>
            </a:r>
            <a:r>
              <a:rPr lang="en-US" altLang="zh-CN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(-Log2)</a:t>
            </a:r>
          </a:p>
          <a:p>
            <a:pPr algn="ctr"/>
            <a:r>
              <a:rPr lang="en-US" altLang="zh-CN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usk vs. other tissues</a:t>
            </a:r>
            <a:endParaRPr lang="zh-CN" altLang="en-US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 rot="18900000">
            <a:off x="320923" y="3835324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09736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8900000">
            <a:off x="1059414" y="3832457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056598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 rot="18900000">
            <a:off x="1817361" y="3829590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02907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 rot="18900000">
            <a:off x="2686414" y="3826723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01644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 rot="18900000">
            <a:off x="3465907" y="3823856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124239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 rot="18900000">
            <a:off x="4260989" y="3820989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396846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 rot="18900000">
            <a:off x="5012003" y="3818122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157166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 rot="18900000">
            <a:off x="5862170" y="3815255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54227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 rot="18900000">
            <a:off x="6679286" y="3812388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04009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 rot="18900000">
            <a:off x="7498355" y="3809521"/>
            <a:ext cx="12634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RMZM2G03642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1082420" y="1265406"/>
            <a:ext cx="288032" cy="123111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TextBox 24"/>
          <p:cNvSpPr txBox="1"/>
          <p:nvPr/>
        </p:nvSpPr>
        <p:spPr>
          <a:xfrm>
            <a:off x="1315367" y="1207769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bry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1082420" y="1439840"/>
            <a:ext cx="288032" cy="123111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1315367" y="1382203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dorsper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1082420" y="1625291"/>
            <a:ext cx="288032" cy="123111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TextBox 28"/>
          <p:cNvSpPr txBox="1"/>
          <p:nvPr/>
        </p:nvSpPr>
        <p:spPr>
          <a:xfrm>
            <a:off x="1315367" y="1567654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082420" y="1821759"/>
            <a:ext cx="288032" cy="123111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TextBox 30"/>
          <p:cNvSpPr txBox="1"/>
          <p:nvPr/>
        </p:nvSpPr>
        <p:spPr>
          <a:xfrm>
            <a:off x="1315367" y="1764122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082420" y="2018227"/>
            <a:ext cx="288032" cy="123111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1315367" y="1960590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the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1082420" y="2203678"/>
            <a:ext cx="288032" cy="123111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TextBox 34"/>
          <p:cNvSpPr txBox="1"/>
          <p:nvPr/>
        </p:nvSpPr>
        <p:spPr>
          <a:xfrm>
            <a:off x="1315367" y="2146041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l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082420" y="2389129"/>
            <a:ext cx="288032" cy="123111"/>
          </a:xfrm>
          <a:prstGeom prst="rect">
            <a:avLst/>
          </a:prstGeom>
          <a:solidFill>
            <a:srgbClr val="6F759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TextBox 36"/>
          <p:cNvSpPr txBox="1"/>
          <p:nvPr/>
        </p:nvSpPr>
        <p:spPr>
          <a:xfrm>
            <a:off x="1315367" y="2331492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asse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图表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1502949"/>
              </p:ext>
            </p:extLst>
          </p:nvPr>
        </p:nvGraphicFramePr>
        <p:xfrm>
          <a:off x="365418" y="1076201"/>
          <a:ext cx="8671078" cy="28042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88192" y="26729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88192" y="234596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88192" y="20501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88192" y="174073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88192" y="14409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88192" y="29882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44910" y="3320979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44910" y="3634265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88192" y="114229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8474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110</Words>
  <Application>Microsoft Office PowerPoint</Application>
  <PresentationFormat>全屏显示(4:3)</PresentationFormat>
  <Paragraphs>30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47</cp:revision>
  <dcterms:created xsi:type="dcterms:W3CDTF">2016-10-07T07:52:27Z</dcterms:created>
  <dcterms:modified xsi:type="dcterms:W3CDTF">2016-11-08T07:21:38Z</dcterms:modified>
</cp:coreProperties>
</file>